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2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A2C18D-D97C-FE4F-8227-06E7E77C1E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69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F9306F79-22FA-0E7C-0257-DDA01EFE2BD9}"/>
              </a:ext>
            </a:extLst>
          </p:cNvPr>
          <p:cNvSpPr txBox="1"/>
          <p:nvPr/>
        </p:nvSpPr>
        <p:spPr>
          <a:xfrm>
            <a:off x="753814" y="4376504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+ T Cells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FD7688A-3E40-E2B4-F1F4-600E1F9BD754}"/>
              </a:ext>
            </a:extLst>
          </p:cNvPr>
          <p:cNvSpPr txBox="1"/>
          <p:nvPr/>
        </p:nvSpPr>
        <p:spPr>
          <a:xfrm>
            <a:off x="1887104" y="4397097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00905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+ T Cells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09A1D10-4653-0328-51DE-18F603B9FA7C}"/>
              </a:ext>
            </a:extLst>
          </p:cNvPr>
          <p:cNvSpPr txBox="1"/>
          <p:nvPr/>
        </p:nvSpPr>
        <p:spPr>
          <a:xfrm>
            <a:off x="3039584" y="4397097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521B9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+ T Cell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9CC9A0F-D663-D02C-F944-D118410B43E8}"/>
              </a:ext>
            </a:extLst>
          </p:cNvPr>
          <p:cNvSpPr txBox="1"/>
          <p:nvPr/>
        </p:nvSpPr>
        <p:spPr>
          <a:xfrm>
            <a:off x="3964329" y="4381786"/>
            <a:ext cx="1109599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FF9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+ Monocytes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1CD3AE9-E03E-BBBE-654B-3B6A162BEAA4}"/>
              </a:ext>
            </a:extLst>
          </p:cNvPr>
          <p:cNvSpPr txBox="1"/>
          <p:nvPr/>
        </p:nvSpPr>
        <p:spPr>
          <a:xfrm>
            <a:off x="5357991" y="4392019"/>
            <a:ext cx="914033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654B4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+ B Cell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7C17BB1-D9C6-6DEC-F487-0B4C56A5C7A1}"/>
              </a:ext>
            </a:extLst>
          </p:cNvPr>
          <p:cNvSpPr txBox="1"/>
          <p:nvPr/>
        </p:nvSpPr>
        <p:spPr>
          <a:xfrm>
            <a:off x="635190" y="2841969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+ T Cell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65C950F-B984-4785-F1DD-16F8AF619083}"/>
              </a:ext>
            </a:extLst>
          </p:cNvPr>
          <p:cNvSpPr txBox="1"/>
          <p:nvPr/>
        </p:nvSpPr>
        <p:spPr>
          <a:xfrm>
            <a:off x="1786729" y="2845663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00905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+ T Cell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C139573-9CD7-5DF9-B2E4-052C724B6423}"/>
              </a:ext>
            </a:extLst>
          </p:cNvPr>
          <p:cNvSpPr txBox="1"/>
          <p:nvPr/>
        </p:nvSpPr>
        <p:spPr>
          <a:xfrm>
            <a:off x="2939209" y="2845663"/>
            <a:ext cx="843501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521B9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+ T Cell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BFABC7A-AAA1-ED68-20C4-763E1DACB96D}"/>
              </a:ext>
            </a:extLst>
          </p:cNvPr>
          <p:cNvSpPr txBox="1"/>
          <p:nvPr/>
        </p:nvSpPr>
        <p:spPr>
          <a:xfrm>
            <a:off x="3952148" y="2838346"/>
            <a:ext cx="1109599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FF9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+ Monocytes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44A69D5-292E-A4EA-5A78-EAA24B36A3BB}"/>
              </a:ext>
            </a:extLst>
          </p:cNvPr>
          <p:cNvSpPr txBox="1"/>
          <p:nvPr/>
        </p:nvSpPr>
        <p:spPr>
          <a:xfrm>
            <a:off x="5197751" y="2830352"/>
            <a:ext cx="914033" cy="220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b="1" dirty="0">
                <a:solidFill>
                  <a:srgbClr val="654B4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+ B Cells</a:t>
            </a: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0EBE5E1C-C958-1FA2-E5BC-9A305C418E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7218"/>
          <a:stretch/>
        </p:blipFill>
        <p:spPr>
          <a:xfrm>
            <a:off x="2471426" y="6004230"/>
            <a:ext cx="1940087" cy="1082385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5C8FC38D-019D-AA13-E772-7291BF94818A}"/>
              </a:ext>
            </a:extLst>
          </p:cNvPr>
          <p:cNvSpPr txBox="1"/>
          <p:nvPr/>
        </p:nvSpPr>
        <p:spPr>
          <a:xfrm>
            <a:off x="3553122" y="6082508"/>
            <a:ext cx="704039" cy="34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r=-0.07264</a:t>
            </a:r>
          </a:p>
          <a:p>
            <a:r>
              <a:rPr lang="en-US" sz="835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=0.9134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B93815D8-59D8-C8E4-089F-7BFECA169B9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2034"/>
          <a:stretch/>
        </p:blipFill>
        <p:spPr>
          <a:xfrm>
            <a:off x="565569" y="5976682"/>
            <a:ext cx="1973142" cy="1143668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091D966F-EF1E-F035-A185-C3C5C8C9BF8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1136"/>
          <a:stretch/>
        </p:blipFill>
        <p:spPr>
          <a:xfrm>
            <a:off x="4371672" y="6009826"/>
            <a:ext cx="2010101" cy="1100603"/>
          </a:xfrm>
          <a:prstGeom prst="rect">
            <a:avLst/>
          </a:prstGeom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0F7014E6-D947-DDE7-7B3C-01E3E6811973}"/>
              </a:ext>
            </a:extLst>
          </p:cNvPr>
          <p:cNvSpPr txBox="1"/>
          <p:nvPr/>
        </p:nvSpPr>
        <p:spPr>
          <a:xfrm>
            <a:off x="5524138" y="5976682"/>
            <a:ext cx="633507" cy="34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r=0.2760</a:t>
            </a:r>
          </a:p>
          <a:p>
            <a:r>
              <a:rPr lang="en-US" sz="835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=0.5637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B73574CD-8BE1-0730-B434-0A1011C5178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7616"/>
          <a:stretch/>
        </p:blipFill>
        <p:spPr>
          <a:xfrm>
            <a:off x="908562" y="7313208"/>
            <a:ext cx="1809998" cy="1098436"/>
          </a:xfrm>
          <a:prstGeom prst="rect">
            <a:avLst/>
          </a:prstGeom>
        </p:spPr>
      </p:pic>
      <p:sp>
        <p:nvSpPr>
          <p:cNvPr id="108" name="TextBox 107">
            <a:extLst>
              <a:ext uri="{FF2B5EF4-FFF2-40B4-BE49-F238E27FC236}">
                <a16:creationId xmlns:a16="http://schemas.microsoft.com/office/drawing/2014/main" id="{8DDB02B9-F901-06B1-BCB6-A888335C0B2E}"/>
              </a:ext>
            </a:extLst>
          </p:cNvPr>
          <p:cNvSpPr txBox="1"/>
          <p:nvPr/>
        </p:nvSpPr>
        <p:spPr>
          <a:xfrm>
            <a:off x="2000115" y="7375187"/>
            <a:ext cx="633507" cy="34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r=0.1646</a:t>
            </a:r>
          </a:p>
          <a:p>
            <a:r>
              <a:rPr lang="en-US" sz="835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=0.5739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5308ABE1-79FB-B81E-3055-9D9464AF825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3916"/>
          <a:stretch/>
        </p:blipFill>
        <p:spPr>
          <a:xfrm>
            <a:off x="3485641" y="7374226"/>
            <a:ext cx="1811427" cy="1098438"/>
          </a:xfrm>
          <a:prstGeom prst="rect">
            <a:avLst/>
          </a:prstGeom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75A36080-BDD3-E066-4DCD-3DD1EB7022D1}"/>
              </a:ext>
            </a:extLst>
          </p:cNvPr>
          <p:cNvSpPr txBox="1"/>
          <p:nvPr/>
        </p:nvSpPr>
        <p:spPr>
          <a:xfrm>
            <a:off x="4543013" y="7432323"/>
            <a:ext cx="633507" cy="34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r=0.1951</a:t>
            </a:r>
          </a:p>
          <a:p>
            <a:r>
              <a:rPr lang="en-US" sz="835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=0.7539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90F345C3-2D78-4BF8-26DD-6BE3CCFE6491}"/>
              </a:ext>
            </a:extLst>
          </p:cNvPr>
          <p:cNvSpPr txBox="1"/>
          <p:nvPr/>
        </p:nvSpPr>
        <p:spPr>
          <a:xfrm rot="16200000">
            <a:off x="28241" y="6329238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+ EV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EE6B186-A362-8312-C848-EB16DCC504CC}"/>
              </a:ext>
            </a:extLst>
          </p:cNvPr>
          <p:cNvSpPr txBox="1"/>
          <p:nvPr/>
        </p:nvSpPr>
        <p:spPr>
          <a:xfrm rot="16200000">
            <a:off x="2006209" y="6311951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+ EV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E0EE3002-A2AB-6650-26E0-C949B22D05F2}"/>
              </a:ext>
            </a:extLst>
          </p:cNvPr>
          <p:cNvSpPr txBox="1"/>
          <p:nvPr/>
        </p:nvSpPr>
        <p:spPr>
          <a:xfrm rot="16200000">
            <a:off x="3872735" y="6215592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+ EV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C3C97B0-6536-6158-83B6-397572B6294A}"/>
              </a:ext>
            </a:extLst>
          </p:cNvPr>
          <p:cNvSpPr txBox="1"/>
          <p:nvPr/>
        </p:nvSpPr>
        <p:spPr>
          <a:xfrm rot="16200000">
            <a:off x="323643" y="7692141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+ EV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CE42F30-4364-EA9F-A56E-9DD013541AEE}"/>
              </a:ext>
            </a:extLst>
          </p:cNvPr>
          <p:cNvSpPr txBox="1"/>
          <p:nvPr/>
        </p:nvSpPr>
        <p:spPr>
          <a:xfrm rot="16200000">
            <a:off x="2913169" y="7684002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+ EV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C02B3508-C493-1A49-AECD-C472423CE585}"/>
              </a:ext>
            </a:extLst>
          </p:cNvPr>
          <p:cNvSpPr txBox="1"/>
          <p:nvPr/>
        </p:nvSpPr>
        <p:spPr>
          <a:xfrm>
            <a:off x="653040" y="7106729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+ PBMC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D06670F-ED23-9495-AE62-803C76ACF419}"/>
              </a:ext>
            </a:extLst>
          </p:cNvPr>
          <p:cNvSpPr txBox="1"/>
          <p:nvPr/>
        </p:nvSpPr>
        <p:spPr>
          <a:xfrm>
            <a:off x="2898648" y="7086616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+ PBMC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EC20FBD-6911-3F6F-635B-CE039EDEA552}"/>
              </a:ext>
            </a:extLst>
          </p:cNvPr>
          <p:cNvSpPr txBox="1"/>
          <p:nvPr/>
        </p:nvSpPr>
        <p:spPr>
          <a:xfrm>
            <a:off x="4814320" y="7072108"/>
            <a:ext cx="1143667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+ PBMC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EDD68E23-CA02-7685-53CB-F81AB31DF365}"/>
              </a:ext>
            </a:extLst>
          </p:cNvPr>
          <p:cNvSpPr txBox="1"/>
          <p:nvPr/>
        </p:nvSpPr>
        <p:spPr>
          <a:xfrm>
            <a:off x="3806813" y="8433522"/>
            <a:ext cx="1438190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+ PBMC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70384E6-0D8A-88F6-9DA2-1BAC520E258E}"/>
              </a:ext>
            </a:extLst>
          </p:cNvPr>
          <p:cNvSpPr txBox="1"/>
          <p:nvPr/>
        </p:nvSpPr>
        <p:spPr>
          <a:xfrm>
            <a:off x="1248024" y="8397543"/>
            <a:ext cx="1438190" cy="22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835" b="1" dirty="0">
                <a:solidFill>
                  <a:srgbClr val="18191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+ PBMCs</a:t>
            </a:r>
            <a:endParaRPr lang="en-CA" sz="835" dirty="0">
              <a:solidFill>
                <a:srgbClr val="18191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diagram of a cell&#10;&#10;Description automatically generated">
            <a:extLst>
              <a:ext uri="{FF2B5EF4-FFF2-40B4-BE49-F238E27FC236}">
                <a16:creationId xmlns:a16="http://schemas.microsoft.com/office/drawing/2014/main" id="{E7AFC14C-021D-4E30-DB8B-301D0401263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1246" y="361680"/>
            <a:ext cx="4083154" cy="24323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A0D3509-F6E0-9768-7647-5494D36B4B2C}"/>
              </a:ext>
            </a:extLst>
          </p:cNvPr>
          <p:cNvSpPr txBox="1"/>
          <p:nvPr/>
        </p:nvSpPr>
        <p:spPr>
          <a:xfrm>
            <a:off x="1478691" y="6064085"/>
            <a:ext cx="704039" cy="34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r=-0.02288</a:t>
            </a:r>
          </a:p>
          <a:p>
            <a:r>
              <a:rPr lang="en-US" sz="835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35" dirty="0">
                <a:latin typeface="Arial" panose="020B0604020202020204" pitchFamily="34" charset="0"/>
                <a:cs typeface="Arial" panose="020B0604020202020204" pitchFamily="34" charset="0"/>
              </a:rPr>
              <a:t>=0.938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9A9A446-A621-C915-E640-05040C97062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0648" y="4605558"/>
            <a:ext cx="1314843" cy="111957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8EC967C-28E7-C506-1B10-E50594D2208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82144" y="4609932"/>
            <a:ext cx="1371062" cy="111668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A59FE6E-0844-A95E-53B0-24B3514B71F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82409" y="4573223"/>
            <a:ext cx="1325268" cy="116343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EF32D20-09F4-BF64-8BE9-E5312642983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40031" y="4626448"/>
            <a:ext cx="1332834" cy="109050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D194B8A-45DD-34A0-4BA6-DBE745939BB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64945" y="4575552"/>
            <a:ext cx="1375044" cy="117470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2F76636-3667-84C7-E86E-DCB899FA698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20636" y="3095275"/>
            <a:ext cx="1394637" cy="118819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A8D4D36-7887-D3CD-336B-4FFDE070A31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619966" y="3095560"/>
            <a:ext cx="1371062" cy="117975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E90C226-45F8-0ACA-404E-ED1408977A5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754309" y="3087401"/>
            <a:ext cx="1384283" cy="1182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3B080E5-5654-8F00-728E-9BA012F2174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942495" y="3108515"/>
            <a:ext cx="1341464" cy="114223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3FE6E31-D0DC-1506-4D6B-228A367BF02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00890" y="3039527"/>
            <a:ext cx="1385667" cy="1202993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E4B9A34-9847-772E-9037-7D978FFB50B5}"/>
              </a:ext>
            </a:extLst>
          </p:cNvPr>
          <p:cNvSpPr txBox="1"/>
          <p:nvPr/>
        </p:nvSpPr>
        <p:spPr>
          <a:xfrm>
            <a:off x="228469" y="361571"/>
            <a:ext cx="571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AAD388E-5E73-46CC-539B-6259076747F9}"/>
              </a:ext>
            </a:extLst>
          </p:cNvPr>
          <p:cNvSpPr txBox="1"/>
          <p:nvPr/>
        </p:nvSpPr>
        <p:spPr>
          <a:xfrm>
            <a:off x="204046" y="2731286"/>
            <a:ext cx="571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44F6E1F-7F66-AB56-F92F-6DD6DBDA80B7}"/>
              </a:ext>
            </a:extLst>
          </p:cNvPr>
          <p:cNvSpPr txBox="1"/>
          <p:nvPr/>
        </p:nvSpPr>
        <p:spPr>
          <a:xfrm>
            <a:off x="190137" y="4271378"/>
            <a:ext cx="571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4F9CABE-F1AF-F3BA-D510-A0FEB5785BC1}"/>
              </a:ext>
            </a:extLst>
          </p:cNvPr>
          <p:cNvSpPr txBox="1"/>
          <p:nvPr/>
        </p:nvSpPr>
        <p:spPr>
          <a:xfrm>
            <a:off x="231036" y="5830565"/>
            <a:ext cx="571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7794D8-443F-7992-4F94-D784D5C47D2F}"/>
              </a:ext>
            </a:extLst>
          </p:cNvPr>
          <p:cNvSpPr txBox="1"/>
          <p:nvPr/>
        </p:nvSpPr>
        <p:spPr>
          <a:xfrm>
            <a:off x="30775" y="4975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</p:spTree>
    <p:extLst>
      <p:ext uri="{BB962C8B-B14F-4D97-AF65-F5344CB8AC3E}">
        <p14:creationId xmlns:p14="http://schemas.microsoft.com/office/powerpoint/2010/main" val="1756180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</TotalTime>
  <Words>116</Words>
  <Application>Microsoft Macintosh PowerPoint</Application>
  <PresentationFormat>Custom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31</cp:revision>
  <cp:lastPrinted>2024-10-15T17:54:31Z</cp:lastPrinted>
  <dcterms:created xsi:type="dcterms:W3CDTF">2024-10-10T14:11:55Z</dcterms:created>
  <dcterms:modified xsi:type="dcterms:W3CDTF">2024-12-20T19:18:45Z</dcterms:modified>
</cp:coreProperties>
</file>